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2"/>
  </p:notesMasterIdLst>
  <p:sldIdLst>
    <p:sldId id="266" r:id="rId2"/>
    <p:sldId id="372" r:id="rId3"/>
    <p:sldId id="382" r:id="rId4"/>
    <p:sldId id="268" r:id="rId5"/>
    <p:sldId id="383" r:id="rId6"/>
    <p:sldId id="269" r:id="rId7"/>
    <p:sldId id="267" r:id="rId8"/>
    <p:sldId id="384" r:id="rId9"/>
    <p:sldId id="380" r:id="rId10"/>
    <p:sldId id="270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E24F8CE-5726-1811-A9E7-2359C5024A75}" name="Nycolas W preite" initials="NW" userId="77cf472a30a36028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0" autoAdjust="0"/>
    <p:restoredTop sz="96106" autoAdjust="0"/>
  </p:normalViewPr>
  <p:slideViewPr>
    <p:cSldViewPr snapToGrid="0">
      <p:cViewPr>
        <p:scale>
          <a:sx n="59" d="100"/>
          <a:sy n="59" d="100"/>
        </p:scale>
        <p:origin x="423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26FC3F-181F-4B43-9153-EF1C043BBD17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0729D6-50FC-F54B-A7E7-4808F8B4E7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18730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76" name="Google Shape;276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Google Shape;286;p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7" name="Google Shape;287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Google Shape;292;p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93" name="Google Shape;293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929233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Google Shape;280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1" name="Google Shape;281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Google Shape;319;p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20" name="Google Shape;320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62660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0815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5033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88066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87947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57980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19373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22186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32896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6191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72027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D9F6-BDB2-7340-985A-A0C2064DC63D}" type="datetimeFigureOut">
              <a:rPr lang="pt-BR" smtClean="0"/>
              <a:t>28/11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3382F-713E-EA47-A1ED-C07E74C41BB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7929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Google Shape;278;p11"/>
          <p:cNvSpPr txBox="1"/>
          <p:nvPr/>
        </p:nvSpPr>
        <p:spPr>
          <a:xfrm>
            <a:off x="1702191" y="3446585"/>
            <a:ext cx="3556551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S</a:t>
            </a: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Google Shape;515;p15"/>
          <p:cNvSpPr txBox="1"/>
          <p:nvPr/>
        </p:nvSpPr>
        <p:spPr>
          <a:xfrm>
            <a:off x="97974" y="97973"/>
            <a:ext cx="262890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5</a:t>
            </a:r>
            <a:endParaRPr sz="1800" dirty="0">
              <a:solidFill>
                <a:srgbClr val="FF0000"/>
              </a:solidFill>
              <a:highlight>
                <a:srgbClr val="FFFF00"/>
              </a:highlight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pic>
        <p:nvPicPr>
          <p:cNvPr id="2" name="Imagem 1">
            <a:extLst>
              <a:ext uri="{FF2B5EF4-FFF2-40B4-BE49-F238E27FC236}">
                <a16:creationId xmlns:a16="http://schemas.microsoft.com/office/drawing/2014/main" id="{754C01C8-C4BA-5306-AFF3-CD9EDC1F73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8607" y="610279"/>
            <a:ext cx="4515764" cy="6528621"/>
          </a:xfrm>
          <a:prstGeom prst="rect">
            <a:avLst/>
          </a:prstGeom>
        </p:spPr>
      </p:pic>
      <p:sp>
        <p:nvSpPr>
          <p:cNvPr id="3" name="CaixaDeTexto 2">
            <a:extLst>
              <a:ext uri="{FF2B5EF4-FFF2-40B4-BE49-F238E27FC236}">
                <a16:creationId xmlns:a16="http://schemas.microsoft.com/office/drawing/2014/main" id="{193208D3-51EB-4672-64AB-871F68443C94}"/>
              </a:ext>
            </a:extLst>
          </p:cNvPr>
          <p:cNvSpPr txBox="1"/>
          <p:nvPr/>
        </p:nvSpPr>
        <p:spPr>
          <a:xfrm>
            <a:off x="375554" y="7445830"/>
            <a:ext cx="5973110" cy="18774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 5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e strategy used to characterize subpopulations of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+Foxp3+ Treg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TCD8+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TCD4+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lymphocytes expressing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ressor (CD39, CTLA-4, PD-1, and PDL-1) and co-stimulatory molecules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ITR, ICOS, and OX40L) present in the lungs of mice at the 8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x 10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iliensi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easts and treated in the course of the disease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rom the 3rd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) with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TLA-4,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D-1, control IgG mAbs or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BS for 5 weeks.</a:t>
            </a:r>
            <a:endParaRPr lang="pt-B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pt-BR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Agrupar 2">
            <a:extLst>
              <a:ext uri="{FF2B5EF4-FFF2-40B4-BE49-F238E27FC236}">
                <a16:creationId xmlns:a16="http://schemas.microsoft.com/office/drawing/2014/main" id="{F198736E-E38F-E591-E858-9F3E02ED34DF}"/>
              </a:ext>
            </a:extLst>
          </p:cNvPr>
          <p:cNvGrpSpPr/>
          <p:nvPr/>
        </p:nvGrpSpPr>
        <p:grpSpPr>
          <a:xfrm>
            <a:off x="143169" y="810257"/>
            <a:ext cx="6714831" cy="7959186"/>
            <a:chOff x="143169" y="810257"/>
            <a:chExt cx="6259387" cy="7419342"/>
          </a:xfrm>
        </p:grpSpPr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94077962-4BAD-594C-AB9F-CF272F62B85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3228500"/>
                </p:ext>
              </p:extLst>
            </p:nvPr>
          </p:nvGraphicFramePr>
          <p:xfrm>
            <a:off x="143169" y="1502229"/>
            <a:ext cx="6159748" cy="67273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lanilha" r:id="rId2" imgW="9817100" imgH="10718800" progId="Excel.Sheet.12">
                    <p:embed/>
                  </p:oleObj>
                </mc:Choice>
                <mc:Fallback>
                  <p:oleObj name="Planilha" r:id="rId2" imgW="9817100" imgH="10718800" progId="Excel.Sheet.12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94077962-4BAD-594C-AB9F-CF272F62B85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43169" y="1502229"/>
                          <a:ext cx="6159748" cy="67273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CaixaDeTexto 1">
              <a:extLst>
                <a:ext uri="{FF2B5EF4-FFF2-40B4-BE49-F238E27FC236}">
                  <a16:creationId xmlns:a16="http://schemas.microsoft.com/office/drawing/2014/main" id="{4820D190-C7B7-8F6F-C343-DD2710B7DD29}"/>
                </a:ext>
              </a:extLst>
            </p:cNvPr>
            <p:cNvSpPr txBox="1"/>
            <p:nvPr/>
          </p:nvSpPr>
          <p:spPr>
            <a:xfrm>
              <a:off x="143169" y="810257"/>
              <a:ext cx="625938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table-1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tibody panels used in assessments </a:t>
              </a:r>
            </a:p>
            <a:p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f lung cell populations by flow cytometry.</a:t>
              </a:r>
              <a:endPara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77636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2">
            <a:extLst>
              <a:ext uri="{FF2B5EF4-FFF2-40B4-BE49-F238E27FC236}">
                <a16:creationId xmlns:a16="http://schemas.microsoft.com/office/drawing/2014/main" id="{D2DA10BF-059D-DC9A-4AF0-5D228400BD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1205059"/>
              </p:ext>
            </p:extLst>
          </p:nvPr>
        </p:nvGraphicFramePr>
        <p:xfrm>
          <a:off x="154493" y="1972008"/>
          <a:ext cx="3230731" cy="65749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67247">
                  <a:extLst>
                    <a:ext uri="{9D8B030D-6E8A-4147-A177-3AD203B41FA5}">
                      <a16:colId xmlns:a16="http://schemas.microsoft.com/office/drawing/2014/main" val="4067708042"/>
                    </a:ext>
                  </a:extLst>
                </a:gridCol>
                <a:gridCol w="606508">
                  <a:extLst>
                    <a:ext uri="{9D8B030D-6E8A-4147-A177-3AD203B41FA5}">
                      <a16:colId xmlns:a16="http://schemas.microsoft.com/office/drawing/2014/main" val="2256529875"/>
                    </a:ext>
                  </a:extLst>
                </a:gridCol>
                <a:gridCol w="749148">
                  <a:extLst>
                    <a:ext uri="{9D8B030D-6E8A-4147-A177-3AD203B41FA5}">
                      <a16:colId xmlns:a16="http://schemas.microsoft.com/office/drawing/2014/main" val="3499133112"/>
                    </a:ext>
                  </a:extLst>
                </a:gridCol>
                <a:gridCol w="592842">
                  <a:extLst>
                    <a:ext uri="{9D8B030D-6E8A-4147-A177-3AD203B41FA5}">
                      <a16:colId xmlns:a16="http://schemas.microsoft.com/office/drawing/2014/main" val="2408515465"/>
                    </a:ext>
                  </a:extLst>
                </a:gridCol>
                <a:gridCol w="714986">
                  <a:extLst>
                    <a:ext uri="{9D8B030D-6E8A-4147-A177-3AD203B41FA5}">
                      <a16:colId xmlns:a16="http://schemas.microsoft.com/office/drawing/2014/main" val="4099948418"/>
                    </a:ext>
                  </a:extLst>
                </a:gridCol>
              </a:tblGrid>
              <a:tr h="356806">
                <a:tc>
                  <a:txBody>
                    <a:bodyPr/>
                    <a:lstStyle/>
                    <a:p>
                      <a:endParaRPr lang="pt-BR" sz="8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600" dirty="0"/>
                        <a:t>Lun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600" dirty="0"/>
                        <a:t>Lun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600" dirty="0"/>
                        <a:t>Liver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600" dirty="0"/>
                        <a:t>Liver</a:t>
                      </a: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2434776139"/>
                  </a:ext>
                </a:extLst>
              </a:tr>
              <a:tr h="503286">
                <a:tc>
                  <a:txBody>
                    <a:bodyPr/>
                    <a:lstStyle/>
                    <a:p>
                      <a:pPr algn="ctr"/>
                      <a:endParaRPr lang="pt-BR" sz="130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PD-1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CTLA-4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PD-1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CTLA-4</a:t>
                      </a: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17738208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3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---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-- 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30626524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6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4163152913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7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++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--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593833806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+</a:t>
                      </a:r>
                      <a:endParaRPr lang="pt-BR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++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766885712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712205119"/>
                  </a:ext>
                </a:extLst>
              </a:tr>
              <a:tr h="680613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407856021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++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67743341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FN-</a:t>
                      </a:r>
                      <a:r>
                        <a:rPr lang="pt-BR" sz="1300" dirty="0">
                          <a:latin typeface="Symbol" pitchFamily="2" charset="2"/>
                        </a:rPr>
                        <a:t>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63609469"/>
                  </a:ext>
                </a:extLst>
              </a:tr>
              <a:tr h="536699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GM-CSF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731390824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2556658605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0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+++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002039702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TGF-</a:t>
                      </a:r>
                      <a:r>
                        <a:rPr lang="pt-BR" sz="1300" dirty="0">
                          <a:latin typeface="Symbol" pitchFamily="2" charset="2"/>
                        </a:rPr>
                        <a:t>b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98759422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4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05339861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5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+</a:t>
                      </a:r>
                      <a:endParaRPr lang="pt-BR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----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--   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245146430"/>
                  </a:ext>
                </a:extLst>
              </a:tr>
            </a:tbl>
          </a:graphicData>
        </a:graphic>
      </p:graphicFrame>
      <p:sp>
        <p:nvSpPr>
          <p:cNvPr id="10" name="CaixaDeTexto 9">
            <a:extLst>
              <a:ext uri="{FF2B5EF4-FFF2-40B4-BE49-F238E27FC236}">
                <a16:creationId xmlns:a16="http://schemas.microsoft.com/office/drawing/2014/main" id="{8CE69048-865E-C466-4E3C-C19342A53401}"/>
              </a:ext>
            </a:extLst>
          </p:cNvPr>
          <p:cNvSpPr txBox="1"/>
          <p:nvPr/>
        </p:nvSpPr>
        <p:spPr>
          <a:xfrm>
            <a:off x="163593" y="1602889"/>
            <a:ext cx="3215192" cy="338554"/>
          </a:xfrm>
          <a:prstGeom prst="rect">
            <a:avLst/>
          </a:prstGeom>
          <a:solidFill>
            <a:schemeClr val="accent3">
              <a:lumMod val="75000"/>
            </a:schemeClr>
          </a:solidFill>
        </p:spPr>
        <p:txBody>
          <a:bodyPr wrap="square">
            <a:spAutoFit/>
          </a:bodyPr>
          <a:lstStyle/>
          <a:p>
            <a:r>
              <a:rPr lang="pt-BR" sz="1600" b="1" dirty="0">
                <a:solidFill>
                  <a:schemeClr val="bg1"/>
                </a:solidFill>
              </a:rPr>
              <a:t>A-Compared with Pb-PBS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75751C60-C1CF-91E1-922F-613857B6EB9B}"/>
              </a:ext>
            </a:extLst>
          </p:cNvPr>
          <p:cNvSpPr txBox="1"/>
          <p:nvPr/>
        </p:nvSpPr>
        <p:spPr>
          <a:xfrm>
            <a:off x="173867" y="436906"/>
            <a:ext cx="652054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4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pt-BR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ble-2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mmary of significant differences in cytokine levels present in lung and liver supernatants of C57BL/6 mice infected with </a:t>
            </a:r>
          </a:p>
          <a:p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brasiliensis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treated with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-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TLA-4 and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D-1 mAbs when compared with Pb-PBS control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Pb-IgG mAb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  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= Increase.     - = Decrease</a:t>
            </a:r>
            <a:endParaRPr lang="pt-B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ela 2">
            <a:extLst>
              <a:ext uri="{FF2B5EF4-FFF2-40B4-BE49-F238E27FC236}">
                <a16:creationId xmlns:a16="http://schemas.microsoft.com/office/drawing/2014/main" id="{DB501994-A200-2E0C-9900-5F92A55208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9309867"/>
              </p:ext>
            </p:extLst>
          </p:nvPr>
        </p:nvGraphicFramePr>
        <p:xfrm>
          <a:off x="3472777" y="1972008"/>
          <a:ext cx="3230730" cy="657805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66030">
                  <a:extLst>
                    <a:ext uri="{9D8B030D-6E8A-4147-A177-3AD203B41FA5}">
                      <a16:colId xmlns:a16="http://schemas.microsoft.com/office/drawing/2014/main" val="4067708042"/>
                    </a:ext>
                  </a:extLst>
                </a:gridCol>
                <a:gridCol w="612440">
                  <a:extLst>
                    <a:ext uri="{9D8B030D-6E8A-4147-A177-3AD203B41FA5}">
                      <a16:colId xmlns:a16="http://schemas.microsoft.com/office/drawing/2014/main" val="2256529875"/>
                    </a:ext>
                  </a:extLst>
                </a:gridCol>
                <a:gridCol w="746975">
                  <a:extLst>
                    <a:ext uri="{9D8B030D-6E8A-4147-A177-3AD203B41FA5}">
                      <a16:colId xmlns:a16="http://schemas.microsoft.com/office/drawing/2014/main" val="3499133112"/>
                    </a:ext>
                  </a:extLst>
                </a:gridCol>
                <a:gridCol w="592428">
                  <a:extLst>
                    <a:ext uri="{9D8B030D-6E8A-4147-A177-3AD203B41FA5}">
                      <a16:colId xmlns:a16="http://schemas.microsoft.com/office/drawing/2014/main" val="2408515465"/>
                    </a:ext>
                  </a:extLst>
                </a:gridCol>
                <a:gridCol w="712857">
                  <a:extLst>
                    <a:ext uri="{9D8B030D-6E8A-4147-A177-3AD203B41FA5}">
                      <a16:colId xmlns:a16="http://schemas.microsoft.com/office/drawing/2014/main" val="4099948418"/>
                    </a:ext>
                  </a:extLst>
                </a:gridCol>
              </a:tblGrid>
              <a:tr h="356806">
                <a:tc>
                  <a:txBody>
                    <a:bodyPr/>
                    <a:lstStyle/>
                    <a:p>
                      <a:endParaRPr lang="pt-BR" sz="8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Lun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Lun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Liver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Liver</a:t>
                      </a: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2434776139"/>
                  </a:ext>
                </a:extLst>
              </a:tr>
              <a:tr h="506401">
                <a:tc>
                  <a:txBody>
                    <a:bodyPr/>
                    <a:lstStyle/>
                    <a:p>
                      <a:pPr algn="ctr"/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PD-1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CTLA-4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PD-1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200" b="1" dirty="0">
                          <a:latin typeface="Symbol" pitchFamily="2" charset="2"/>
                        </a:rPr>
                        <a:t>a</a:t>
                      </a:r>
                      <a:r>
                        <a:rPr lang="pt-BR" sz="1200" b="1" dirty="0"/>
                        <a:t>-CTLA-4</a:t>
                      </a: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17738208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3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700" dirty="0"/>
                        <a:t>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30626524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6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4163152913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7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593833806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pt-BR" sz="1700" dirty="0"/>
                        <a:t> </a:t>
                      </a:r>
                      <a:r>
                        <a:rPr lang="en-US" sz="1700" dirty="0"/>
                        <a:t>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766885712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712205119"/>
                  </a:ext>
                </a:extLst>
              </a:tr>
              <a:tr h="680613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+</a:t>
                      </a:r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407856021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2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++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67743341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FN-</a:t>
                      </a:r>
                      <a:r>
                        <a:rPr lang="pt-BR" sz="1300" dirty="0">
                          <a:latin typeface="Symbol" pitchFamily="2" charset="2"/>
                        </a:rPr>
                        <a:t>g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63609469"/>
                  </a:ext>
                </a:extLst>
              </a:tr>
              <a:tr h="536698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GM-CSF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300" dirty="0"/>
                        <a:t>+</a:t>
                      </a:r>
                      <a:endParaRPr lang="pt-BR" sz="1300" dirty="0"/>
                    </a:p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731390824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2556658605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10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++++ 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1002039702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TGF-</a:t>
                      </a:r>
                      <a:r>
                        <a:rPr lang="pt-BR" sz="1300" dirty="0">
                          <a:latin typeface="Symbol" pitchFamily="2" charset="2"/>
                        </a:rPr>
                        <a:t>b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987594220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4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053398619"/>
                  </a:ext>
                </a:extLst>
              </a:tr>
              <a:tr h="374795">
                <a:tc>
                  <a:txBody>
                    <a:bodyPr/>
                    <a:lstStyle/>
                    <a:p>
                      <a:pPr algn="ctr"/>
                      <a:r>
                        <a:rPr lang="pt-BR" sz="1300" dirty="0"/>
                        <a:t>IL-5</a:t>
                      </a:r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+</a:t>
                      </a:r>
                      <a:endParaRPr lang="pt-BR" sz="13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/>
                        <a:t>+</a:t>
                      </a:r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endParaRPr lang="pt-BR" sz="1700" dirty="0"/>
                    </a:p>
                  </a:txBody>
                  <a:tcPr marL="58435" marR="58435" marT="29217" marB="2921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700" dirty="0"/>
                        <a:t>   </a:t>
                      </a:r>
                      <a:endParaRPr lang="pt-BR" sz="1700" dirty="0">
                        <a:highlight>
                          <a:srgbClr val="FFFF00"/>
                        </a:highlight>
                      </a:endParaRPr>
                    </a:p>
                  </a:txBody>
                  <a:tcPr marL="58435" marR="58435" marT="29217" marB="29217"/>
                </a:tc>
                <a:extLst>
                  <a:ext uri="{0D108BD9-81ED-4DB2-BD59-A6C34878D82A}">
                    <a16:rowId xmlns:a16="http://schemas.microsoft.com/office/drawing/2014/main" val="3245146430"/>
                  </a:ext>
                </a:extLst>
              </a:tr>
            </a:tbl>
          </a:graphicData>
        </a:graphic>
      </p:graphicFrame>
      <p:sp>
        <p:nvSpPr>
          <p:cNvPr id="11" name="CaixaDeTexto 10">
            <a:extLst>
              <a:ext uri="{FF2B5EF4-FFF2-40B4-BE49-F238E27FC236}">
                <a16:creationId xmlns:a16="http://schemas.microsoft.com/office/drawing/2014/main" id="{ADBAC42F-BCCD-F653-7830-9580E97F315C}"/>
              </a:ext>
            </a:extLst>
          </p:cNvPr>
          <p:cNvSpPr txBox="1"/>
          <p:nvPr/>
        </p:nvSpPr>
        <p:spPr>
          <a:xfrm>
            <a:off x="3479218" y="1602885"/>
            <a:ext cx="3215191" cy="338554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square">
            <a:spAutoFit/>
          </a:bodyPr>
          <a:lstStyle/>
          <a:p>
            <a:r>
              <a:rPr lang="pt-BR" sz="1600" b="1" dirty="0">
                <a:solidFill>
                  <a:schemeClr val="bg1"/>
                </a:solidFill>
              </a:rPr>
              <a:t>B- Compared with Pb-IgG</a:t>
            </a:r>
            <a:r>
              <a:rPr lang="pt-BR" sz="1600" b="1" dirty="0">
                <a:solidFill>
                  <a:schemeClr val="bg1"/>
                </a:solidFill>
                <a:highlight>
                  <a:srgbClr val="FFFF00"/>
                </a:highlight>
              </a:rPr>
              <a:t> </a:t>
            </a:r>
            <a:endParaRPr lang="pt-BR" sz="16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3485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Google Shape;290;p13"/>
          <p:cNvSpPr txBox="1"/>
          <p:nvPr/>
        </p:nvSpPr>
        <p:spPr>
          <a:xfrm>
            <a:off x="101841" y="146961"/>
            <a:ext cx="3294505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 Figure 1</a:t>
            </a:r>
            <a:endParaRPr sz="1800" dirty="0">
              <a:solidFill>
                <a:srgbClr val="FF0000"/>
              </a:solidFill>
              <a:highlight>
                <a:srgbClr val="FFFF00"/>
              </a:highlight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pSp>
        <p:nvGrpSpPr>
          <p:cNvPr id="3" name="Agrupar 2">
            <a:extLst>
              <a:ext uri="{FF2B5EF4-FFF2-40B4-BE49-F238E27FC236}">
                <a16:creationId xmlns:a16="http://schemas.microsoft.com/office/drawing/2014/main" id="{5AD0203E-2BC4-A64C-B4BC-63DCBFD85029}"/>
              </a:ext>
            </a:extLst>
          </p:cNvPr>
          <p:cNvGrpSpPr/>
          <p:nvPr/>
        </p:nvGrpSpPr>
        <p:grpSpPr>
          <a:xfrm>
            <a:off x="309605" y="577599"/>
            <a:ext cx="6238790" cy="8750802"/>
            <a:chOff x="-28790" y="578936"/>
            <a:chExt cx="6524755" cy="8748128"/>
          </a:xfrm>
        </p:grpSpPr>
        <p:sp>
          <p:nvSpPr>
            <p:cNvPr id="2" name="CaixaDeTexto 1">
              <a:extLst>
                <a:ext uri="{FF2B5EF4-FFF2-40B4-BE49-F238E27FC236}">
                  <a16:creationId xmlns:a16="http://schemas.microsoft.com/office/drawing/2014/main" id="{5706C150-E876-5291-1375-9E85DDF58CCC}"/>
                </a:ext>
              </a:extLst>
            </p:cNvPr>
            <p:cNvSpPr txBox="1"/>
            <p:nvPr/>
          </p:nvSpPr>
          <p:spPr>
            <a:xfrm>
              <a:off x="-28790" y="61329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" name="CaixaDeTexto 3">
              <a:extLst>
                <a:ext uri="{FF2B5EF4-FFF2-40B4-BE49-F238E27FC236}">
                  <a16:creationId xmlns:a16="http://schemas.microsoft.com/office/drawing/2014/main" id="{FD71C4B3-CE32-7B1C-AB62-87BDD549383A}"/>
                </a:ext>
              </a:extLst>
            </p:cNvPr>
            <p:cNvSpPr txBox="1"/>
            <p:nvPr/>
          </p:nvSpPr>
          <p:spPr>
            <a:xfrm>
              <a:off x="728810" y="179141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6DE50ED6-5ABC-C242-9177-78D3BC9FE38D}"/>
                </a:ext>
              </a:extLst>
            </p:cNvPr>
            <p:cNvSpPr txBox="1"/>
            <p:nvPr/>
          </p:nvSpPr>
          <p:spPr>
            <a:xfrm>
              <a:off x="843109" y="604496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7" name="Imagem 6">
              <a:extLst>
                <a:ext uri="{FF2B5EF4-FFF2-40B4-BE49-F238E27FC236}">
                  <a16:creationId xmlns:a16="http://schemas.microsoft.com/office/drawing/2014/main" id="{B358C638-8387-E44F-9434-F46A38CDDE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2035" y="578936"/>
              <a:ext cx="6133930" cy="8748128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05416016-0795-0857-6F33-A6E176E4C387}"/>
              </a:ext>
            </a:extLst>
          </p:cNvPr>
          <p:cNvSpPr txBox="1"/>
          <p:nvPr/>
        </p:nvSpPr>
        <p:spPr>
          <a:xfrm>
            <a:off x="163278" y="469067"/>
            <a:ext cx="6384470" cy="29238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</a:t>
            </a:r>
            <a:r>
              <a:rPr 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entary Figure-1</a:t>
            </a:r>
            <a:r>
              <a:rPr lang="en-US" sz="16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e strategy used to characterize vasculature and parenchyma lung cell subpopulations by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SN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T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d (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y1.2+TC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CR</a:t>
            </a:r>
            <a:r>
              <a:rPr lang="en-US" sz="14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d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), ILCs (Thy1.2+TC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CR</a:t>
            </a:r>
            <a:r>
              <a:rPr lang="en-US" sz="14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d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),  ILC1 (Thy1.2+Lin-Tbet+), ILC2 (Thy1.1+Lin-GATA3+), ILC3 (Thy1.2+Lin-RO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), ILC1 NK+ (Thy1.2+Lin-Tbet+NK1.1+RO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), ILC3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ti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Thy1.2+Lin-RO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Tbet-CD4+), and ILC3 NCR+ (Thy1.2+LinROR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Tbet+NKp46+CD4) Innate Lymphoid Cells as well as Adaptive Immune T cells (TCD8, TCD4, Th1, Th2, Th17, and Tregs expressing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be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R</a:t>
            </a:r>
            <a:r>
              <a:rPr lang="en-US" sz="14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t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GATA3 transcription factors)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Gate strategy to characterize TCD4 cells expressing maturation markers (CD44, CD62L), as well as TCD4+Foxp3+ Treg cells expressing activation (CD73, CD39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ropilin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the transcription factor (Helios) markers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Cells were obtained from the lungs of mice at the 8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1 x 10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iliensi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easts and treated in the course of the disease (from the 3rd week p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) with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TLA-4,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D-1, control IgG mAbs or PBS for 5 weeks.</a:t>
            </a:r>
            <a:endParaRPr lang="pt-BR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11985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515;p15">
            <a:extLst>
              <a:ext uri="{FF2B5EF4-FFF2-40B4-BE49-F238E27FC236}">
                <a16:creationId xmlns:a16="http://schemas.microsoft.com/office/drawing/2014/main" id="{8A7A5E6D-4D50-2746-8CB0-BBBCAC5F4A4E}"/>
              </a:ext>
            </a:extLst>
          </p:cNvPr>
          <p:cNvSpPr txBox="1"/>
          <p:nvPr/>
        </p:nvSpPr>
        <p:spPr>
          <a:xfrm>
            <a:off x="127145" y="80885"/>
            <a:ext cx="2761273" cy="3719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</a:t>
            </a:r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ementary Figure 2</a:t>
            </a:r>
            <a:r>
              <a:rPr lang="en-US" sz="1800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endParaRPr sz="1800" dirty="0">
              <a:solidFill>
                <a:srgbClr val="FF0000"/>
              </a:solidFill>
              <a:highlight>
                <a:srgbClr val="FFFF00"/>
              </a:highlight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pSp>
        <p:nvGrpSpPr>
          <p:cNvPr id="4" name="Agrupar 3">
            <a:extLst>
              <a:ext uri="{FF2B5EF4-FFF2-40B4-BE49-F238E27FC236}">
                <a16:creationId xmlns:a16="http://schemas.microsoft.com/office/drawing/2014/main" id="{B75B249B-A2C9-7E51-DD00-0876B4C93B56}"/>
              </a:ext>
            </a:extLst>
          </p:cNvPr>
          <p:cNvGrpSpPr/>
          <p:nvPr/>
        </p:nvGrpSpPr>
        <p:grpSpPr>
          <a:xfrm>
            <a:off x="145215" y="312268"/>
            <a:ext cx="6557482" cy="9021996"/>
            <a:chOff x="145215" y="312268"/>
            <a:chExt cx="6557482" cy="9021996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AC27681A-7CC0-BBA3-F047-01AAF76047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0014506"/>
                </p:ext>
              </p:extLst>
            </p:nvPr>
          </p:nvGraphicFramePr>
          <p:xfrm>
            <a:off x="145215" y="312268"/>
            <a:ext cx="6557482" cy="71081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5082955" imgH="5360533" progId="Prism9.Document">
                    <p:embed/>
                  </p:oleObj>
                </mc:Choice>
                <mc:Fallback>
                  <p:oleObj name="Prism 9" r:id="rId3" imgW="5082955" imgH="5360533" progId="Prism9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AC27681A-7CC0-BBA3-F047-01AAF76047E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45215" y="312268"/>
                          <a:ext cx="6557482" cy="71081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to 4">
              <a:extLst>
                <a:ext uri="{FF2B5EF4-FFF2-40B4-BE49-F238E27FC236}">
                  <a16:creationId xmlns:a16="http://schemas.microsoft.com/office/drawing/2014/main" id="{11C19E9E-8832-9B38-7BEC-850D9F20CE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07176409"/>
                </p:ext>
              </p:extLst>
            </p:nvPr>
          </p:nvGraphicFramePr>
          <p:xfrm>
            <a:off x="4669897" y="1304752"/>
            <a:ext cx="1654862" cy="14823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1585678" imgH="1417926" progId="Prism9.Document">
                    <p:embed/>
                  </p:oleObj>
                </mc:Choice>
                <mc:Fallback>
                  <p:oleObj name="Prism 9" r:id="rId5" imgW="1585678" imgH="1417926" progId="Prism9.Document">
                    <p:embed/>
                    <p:pic>
                      <p:nvPicPr>
                        <p:cNvPr id="5" name="Objeto 4">
                          <a:extLst>
                            <a:ext uri="{FF2B5EF4-FFF2-40B4-BE49-F238E27FC236}">
                              <a16:creationId xmlns:a16="http://schemas.microsoft.com/office/drawing/2014/main" id="{11C19E9E-8832-9B38-7BEC-850D9F20CE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669897" y="1304752"/>
                          <a:ext cx="1654862" cy="14823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CaixaDeTexto 2">
              <a:extLst>
                <a:ext uri="{FF2B5EF4-FFF2-40B4-BE49-F238E27FC236}">
                  <a16:creationId xmlns:a16="http://schemas.microsoft.com/office/drawing/2014/main" id="{B87BD80A-DC23-D1BD-C847-F1A863CCFE0E}"/>
                </a:ext>
              </a:extLst>
            </p:cNvPr>
            <p:cNvSpPr txBox="1"/>
            <p:nvPr/>
          </p:nvSpPr>
          <p:spPr>
            <a:xfrm>
              <a:off x="179612" y="7518382"/>
              <a:ext cx="6361998" cy="18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e</a:t>
              </a:r>
              <a:r>
                <a:rPr lang="en-US" sz="1400" b="1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Figure 2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umber of T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d (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hy1.2+TC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,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CR</a:t>
              </a:r>
              <a:r>
                <a:rPr lang="en-US" sz="1400" dirty="0" err="1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d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+), total ILCs 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Thy1.2+TC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,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CR</a:t>
              </a:r>
              <a:r>
                <a:rPr lang="en-US" sz="1400" dirty="0" err="1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d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), ILC1 (Thy1.2+Lin-Tbet+), ILC2 (Thy1.1+Lin-GATA3+), 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LC3 (Thy1.2+Lin-RO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t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+), ILC1 NK+ (Thy1.2+Lin-Tbet+NK1.1+RO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t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), 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LC3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Lti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Thy1.2+Lin-RO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t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+Tbet-CD4+), and ILC3 NCR+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Thy1.2+Lin-ROR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gt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+Tbet+NKp46+CD4-) cells present in the lungs of mice 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 the 8th</a:t>
              </a:r>
              <a:r>
                <a:rPr lang="en-US" sz="1400" baseline="30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week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.i.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with 1 x 10</a:t>
              </a:r>
              <a:r>
                <a:rPr lang="en-US" sz="1400" baseline="30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6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. </a:t>
              </a:r>
              <a:r>
                <a:rPr lang="en-US" sz="1400" i="1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rasiliensis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yeasts and treated throughout the 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ourse of the disease (3rd week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.i.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on) with  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CTLA-4, </a:t>
              </a:r>
              <a:r>
                <a:rPr lang="en-US" sz="1400" dirty="0">
                  <a:effectLst/>
                  <a:latin typeface="Symbol" pitchFamily="2" charset="2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PD-1, and</a:t>
              </a:r>
            </a:p>
            <a:p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ntrol IgG mAbs or PBS for 5 weeks.</a:t>
              </a:r>
              <a:r>
                <a:rPr lang="en-US" sz="14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ignificant difference, **</a:t>
              </a:r>
              <a:r>
                <a:rPr lang="en-US" sz="14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&lt;0.01.</a:t>
              </a:r>
              <a:endParaRPr lang="pt-BR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422851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Google Shape;284;p12"/>
          <p:cNvSpPr txBox="1"/>
          <p:nvPr/>
        </p:nvSpPr>
        <p:spPr>
          <a:xfrm>
            <a:off x="163482" y="398150"/>
            <a:ext cx="274583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FF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 3 </a:t>
            </a:r>
            <a:endParaRPr sz="1800" dirty="0">
              <a:solidFill>
                <a:srgbClr val="FF0000"/>
              </a:solidFill>
              <a:highlight>
                <a:srgbClr val="FFFF00"/>
              </a:highlight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01130FCD-A7A9-A64C-8B43-A7602395ED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482" y="767441"/>
            <a:ext cx="6477172" cy="8181107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EDF4DB19-2D34-A4BE-9AF1-382E3C737496}"/>
              </a:ext>
            </a:extLst>
          </p:cNvPr>
          <p:cNvSpPr txBox="1"/>
          <p:nvPr/>
        </p:nvSpPr>
        <p:spPr>
          <a:xfrm>
            <a:off x="310241" y="849088"/>
            <a:ext cx="6281463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 </a:t>
            </a:r>
            <a:r>
              <a:rPr lang="en-US" sz="14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e strategy used to characterize Neutrophils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D11b+ Ly6G+), Monocytes (CD11b+Ly6C+MHC II -), Inflammatory Monocytes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11b+ Ly6C+ MHCII+), Macrophages (CD11b+ F4/80+) and Dendritic Cells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Cs, CD11c+ MHCII+) expressing activation markers (CD40, CD80, CD86,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HCII) and the enzyme indoleamin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oxygenas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DO), present in the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ngs of mice at the 8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1 x 10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iliensi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easts and treated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course of the disease (from the 3rd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) with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TLA-4,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D-1,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IgG mAbs or PBS for 5 weeks.</a:t>
            </a:r>
            <a:endParaRPr lang="pt-B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72308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196518EF-7263-CE4A-804D-594993831751}"/>
              </a:ext>
            </a:extLst>
          </p:cNvPr>
          <p:cNvSpPr txBox="1"/>
          <p:nvPr/>
        </p:nvSpPr>
        <p:spPr>
          <a:xfrm>
            <a:off x="213071" y="521228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</a:p>
        </p:txBody>
      </p:sp>
      <p:pic>
        <p:nvPicPr>
          <p:cNvPr id="223" name="Imagem 222">
            <a:extLst>
              <a:ext uri="{FF2B5EF4-FFF2-40B4-BE49-F238E27FC236}">
                <a16:creationId xmlns:a16="http://schemas.microsoft.com/office/drawing/2014/main" id="{F65091F9-801C-C7C1-2F28-5EA6890ADD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071" y="890560"/>
            <a:ext cx="6351532" cy="5363286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B68F34C6-23B2-A3CB-3AB9-C6488A257DD7}"/>
              </a:ext>
            </a:extLst>
          </p:cNvPr>
          <p:cNvSpPr txBox="1"/>
          <p:nvPr/>
        </p:nvSpPr>
        <p:spPr>
          <a:xfrm>
            <a:off x="130625" y="6477354"/>
            <a:ext cx="661307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</a:t>
            </a:r>
            <a:r>
              <a:rPr 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entary figure 4 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e strategy used to characterize the expression of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racellular cytokines (IFN-g, IL-5, IL1-7, and IL-22) by ILCs and TCD4+ lymphocytes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Expression of intracellular IL-12, TNF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-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L-10) and th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R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anscription factor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y Monocytes and Dendritic Cells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rom lungs of mice at the 8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x 10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iliensi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easts and treated throughout the course of the disease </a:t>
            </a:r>
          </a:p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3rd week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) with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TLA-4, </a:t>
            </a:r>
            <a:r>
              <a:rPr lang="en-US" sz="14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D-1, control IgG mAbs or PBS for 5 weeks.</a:t>
            </a:r>
            <a:endParaRPr lang="pt-B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07355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50</TotalTime>
  <Words>893</Words>
  <Application>Microsoft Office PowerPoint</Application>
  <PresentationFormat>Papel A4 (210 x 297 mm)</PresentationFormat>
  <Paragraphs>134</Paragraphs>
  <Slides>10</Slides>
  <Notes>5</Notes>
  <HiddenSlides>0</HiddenSlides>
  <MMClips>0</MMClips>
  <ScaleCrop>false</ScaleCrop>
  <HeadingPairs>
    <vt:vector size="8" baseType="variant">
      <vt:variant>
        <vt:lpstr>Fo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2</vt:i4>
      </vt:variant>
      <vt:variant>
        <vt:lpstr>Títulos de slides</vt:lpstr>
      </vt:variant>
      <vt:variant>
        <vt:i4>10</vt:i4>
      </vt:variant>
    </vt:vector>
  </HeadingPairs>
  <TitlesOfParts>
    <vt:vector size="18" baseType="lpstr">
      <vt:lpstr>Arial</vt:lpstr>
      <vt:lpstr>Calibri</vt:lpstr>
      <vt:lpstr>Calibri Light</vt:lpstr>
      <vt:lpstr>Symbol</vt:lpstr>
      <vt:lpstr>Times New Roman</vt:lpstr>
      <vt:lpstr>Tema do Office</vt:lpstr>
      <vt:lpstr>Planilha</vt:lpstr>
      <vt:lpstr>Prism 9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Nycolas W preite</cp:lastModifiedBy>
  <cp:revision>50</cp:revision>
  <dcterms:created xsi:type="dcterms:W3CDTF">2023-10-06T17:32:26Z</dcterms:created>
  <dcterms:modified xsi:type="dcterms:W3CDTF">2023-11-28T18:52:32Z</dcterms:modified>
</cp:coreProperties>
</file>